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90360" y="767880"/>
            <a:ext cx="5118120" cy="3837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  <a:defRPr b="0" lang="fr-F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5944770D-17DB-4B76-B994-D3175F5FBDC7}" type="slidenum">
              <a:rPr b="0" lang="fr-F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7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7F5ECF33-1E65-4DF6-8B76-0ED91362F1E5}" type="slidenum">
              <a:rPr b="0" lang="fr-F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7246A-FE6A-4EC5-8F84-9F6338EAA6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6363C-119D-4068-A63F-98E461ACCE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1D15DF-120B-4458-B92B-5FCBFA40C2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5F0E1-48E4-491B-BD64-C81F61BC99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0314B-F375-4DF7-BFB8-4173D8A774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446D2-14ED-473E-B013-7EA9049CE4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CB9C9-F06D-42A0-BC94-A8894F4783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2FD4F-F068-4ECA-92B8-3E107F8C79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D4C259-AFBE-4BA4-BB48-5A681F8665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CEEC3-DD03-4E4A-BF9A-18FF8DD0FB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A45F5-A2C3-4C49-B1F4-A46C3F58A9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C45AF-1A55-42CD-A18A-B9828FB98A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BB7FF6-F2E6-4157-95C3-777AB355B0A3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611280" y="1052640"/>
            <a:ext cx="7705800" cy="4289400"/>
          </a:xfrm>
          <a:prstGeom prst="rect">
            <a:avLst/>
          </a:prstGeom>
          <a:ln w="0">
            <a:noFill/>
          </a:ln>
        </p:spPr>
      </p:pic>
      <p:sp>
        <p:nvSpPr>
          <p:cNvPr id="49" name="Text Box 5"/>
          <p:cNvSpPr/>
          <p:nvPr/>
        </p:nvSpPr>
        <p:spPr>
          <a:xfrm>
            <a:off x="468360" y="333360"/>
            <a:ext cx="7775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4. Determination of the optimal number of reference genes required for normalization using geNorm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"/>
          <p:cNvSpPr/>
          <p:nvPr/>
        </p:nvSpPr>
        <p:spPr>
          <a:xfrm rot="16200000">
            <a:off x="-1811520" y="3116520"/>
            <a:ext cx="46087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Pairwise vari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2411280" y="5157720"/>
            <a:ext cx="46087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Arial"/>
              </a:rPr>
              <a:t>Pair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8"/>
          <p:cNvSpPr/>
          <p:nvPr/>
        </p:nvSpPr>
        <p:spPr>
          <a:xfrm>
            <a:off x="1476360" y="4941720"/>
            <a:ext cx="669600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2/3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     3/4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           4/5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               5/6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  6/7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       7/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ZoneTexte 6"/>
          <p:cNvSpPr/>
          <p:nvPr/>
        </p:nvSpPr>
        <p:spPr>
          <a:xfrm>
            <a:off x="826920" y="5516640"/>
            <a:ext cx="7417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gend: The program calculates the pairwise variation (V) between two sequential normalization factors (in x-axis). V2/3 indicates the variation in the normalization factor using two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rsu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hree genes. A large pairwise variation V indicates that the added gene has a significant effect and should preferably be included in the normalization. Vandesompele et al. [23] suggest that the cut-off value for such significance should be 0.15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3T09:10:26Z</dcterms:created>
  <dc:creator>chapuis</dc:creator>
  <dc:description/>
  <dc:language>en-US</dc:language>
  <cp:lastModifiedBy>CHAPUIS</cp:lastModifiedBy>
  <dcterms:modified xsi:type="dcterms:W3CDTF">2011-02-02T17:49:51Z</dcterms:modified>
  <cp:revision>15</cp:revision>
  <dc:subject/>
  <dc:title>Diapositive 1</dc:title>
</cp:coreProperties>
</file>